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261" r:id="rId2"/>
  </p:sldIdLst>
  <p:sldSz cx="22860000" cy="310896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9792" userDrawn="1">
          <p15:clr>
            <a:srgbClr val="A4A3A4"/>
          </p15:clr>
        </p15:guide>
        <p15:guide id="2" pos="7200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91F6BA65-27D7-86ED-47D5-35B0D43FF38A}" name="Kaynak, Ahmet (kaynakat)" initials="KA(" userId="S::kaynakat@ucmail.uc.edu::e30822f5-f881-493f-bf88-3d523b0e27a6" providerId="AD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Kaynak, Ahmet (kaynakat)" initials="KA(" lastIdx="9" clrIdx="0">
    <p:extLst>
      <p:ext uri="{19B8F6BF-5375-455C-9EA6-DF929625EA0E}">
        <p15:presenceInfo xmlns:p15="http://schemas.microsoft.com/office/powerpoint/2012/main" userId="S::kaynakat@mail.uc.edu::e30822f5-f881-493f-bf88-3d523b0e27a6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189" autoAdjust="0"/>
    <p:restoredTop sz="96973" autoAdjust="0"/>
  </p:normalViewPr>
  <p:slideViewPr>
    <p:cSldViewPr snapToGrid="0">
      <p:cViewPr varScale="1">
        <p:scale>
          <a:sx n="36" d="100"/>
          <a:sy n="36" d="100"/>
        </p:scale>
        <p:origin x="3748" y="120"/>
      </p:cViewPr>
      <p:guideLst>
        <p:guide orient="horz" pos="9792"/>
        <p:guide pos="720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8/10/relationships/authors" Target="authors.xml"/><Relationship Id="rId4" Type="http://schemas.openxmlformats.org/officeDocument/2006/relationships/commentAuthors" Target="commentAuthors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aynak, Ahmet (kaynakat)" userId="e30822f5-f881-493f-bf88-3d523b0e27a6" providerId="ADAL" clId="{B8D3896F-3B37-463B-899F-CD1E335C8BD0}"/>
    <pc:docChg chg="custSel modSld">
      <pc:chgData name="Kaynak, Ahmet (kaynakat)" userId="e30822f5-f881-493f-bf88-3d523b0e27a6" providerId="ADAL" clId="{B8D3896F-3B37-463B-899F-CD1E335C8BD0}" dt="2025-01-27T17:22:57.597" v="19" actId="1076"/>
      <pc:docMkLst>
        <pc:docMk/>
      </pc:docMkLst>
      <pc:sldChg chg="delSp modSp mod">
        <pc:chgData name="Kaynak, Ahmet (kaynakat)" userId="e30822f5-f881-493f-bf88-3d523b0e27a6" providerId="ADAL" clId="{B8D3896F-3B37-463B-899F-CD1E335C8BD0}" dt="2025-01-27T17:22:57.597" v="19" actId="1076"/>
        <pc:sldMkLst>
          <pc:docMk/>
          <pc:sldMk cId="285981273" sldId="261"/>
        </pc:sldMkLst>
        <pc:spChg chg="mod">
          <ac:chgData name="Kaynak, Ahmet (kaynakat)" userId="e30822f5-f881-493f-bf88-3d523b0e27a6" providerId="ADAL" clId="{B8D3896F-3B37-463B-899F-CD1E335C8BD0}" dt="2025-01-27T17:22:57.597" v="19" actId="1076"/>
          <ac:spMkLst>
            <pc:docMk/>
            <pc:sldMk cId="285981273" sldId="261"/>
            <ac:spMk id="2" creationId="{08ED3A1F-41A4-AB98-FC88-46D599EAAA97}"/>
          </ac:spMkLst>
        </pc:spChg>
        <pc:spChg chg="del">
          <ac:chgData name="Kaynak, Ahmet (kaynakat)" userId="e30822f5-f881-493f-bf88-3d523b0e27a6" providerId="ADAL" clId="{B8D3896F-3B37-463B-899F-CD1E335C8BD0}" dt="2025-01-27T17:22:48.079" v="18" actId="478"/>
          <ac:spMkLst>
            <pc:docMk/>
            <pc:sldMk cId="285981273" sldId="261"/>
            <ac:spMk id="3" creationId="{BE06BC0C-2A7B-DA80-068E-407871B9E8DC}"/>
          </ac:spMkLst>
        </pc:spChg>
        <pc:spChg chg="mod">
          <ac:chgData name="Kaynak, Ahmet (kaynakat)" userId="e30822f5-f881-493f-bf88-3d523b0e27a6" providerId="ADAL" clId="{B8D3896F-3B37-463B-899F-CD1E335C8BD0}" dt="2025-01-27T17:22:37.271" v="17" actId="20577"/>
          <ac:spMkLst>
            <pc:docMk/>
            <pc:sldMk cId="285981273" sldId="261"/>
            <ac:spMk id="18" creationId="{9CE66A8D-058D-3B13-CE63-2BDBA44AA9C7}"/>
          </ac:spMkLst>
        </pc:spChg>
        <pc:spChg chg="mod">
          <ac:chgData name="Kaynak, Ahmet (kaynakat)" userId="e30822f5-f881-493f-bf88-3d523b0e27a6" providerId="ADAL" clId="{B8D3896F-3B37-463B-899F-CD1E335C8BD0}" dt="2025-01-27T17:22:57.597" v="19" actId="1076"/>
          <ac:spMkLst>
            <pc:docMk/>
            <pc:sldMk cId="285981273" sldId="261"/>
            <ac:spMk id="29" creationId="{F42B4A5F-09E1-1CA7-DC99-4C350DF435DC}"/>
          </ac:spMkLst>
        </pc:spChg>
        <pc:spChg chg="mod">
          <ac:chgData name="Kaynak, Ahmet (kaynakat)" userId="e30822f5-f881-493f-bf88-3d523b0e27a6" providerId="ADAL" clId="{B8D3896F-3B37-463B-899F-CD1E335C8BD0}" dt="2025-01-27T17:22:57.597" v="19" actId="1076"/>
          <ac:spMkLst>
            <pc:docMk/>
            <pc:sldMk cId="285981273" sldId="261"/>
            <ac:spMk id="31" creationId="{F026F0A9-669B-B7EA-8FFD-EE5446FD80CF}"/>
          </ac:spMkLst>
        </pc:spChg>
        <pc:spChg chg="mod">
          <ac:chgData name="Kaynak, Ahmet (kaynakat)" userId="e30822f5-f881-493f-bf88-3d523b0e27a6" providerId="ADAL" clId="{B8D3896F-3B37-463B-899F-CD1E335C8BD0}" dt="2025-01-27T17:22:57.597" v="19" actId="1076"/>
          <ac:spMkLst>
            <pc:docMk/>
            <pc:sldMk cId="285981273" sldId="261"/>
            <ac:spMk id="35" creationId="{10738D71-9A2F-6448-FC18-A2DDCD9BEF70}"/>
          </ac:spMkLst>
        </pc:spChg>
        <pc:spChg chg="mod">
          <ac:chgData name="Kaynak, Ahmet (kaynakat)" userId="e30822f5-f881-493f-bf88-3d523b0e27a6" providerId="ADAL" clId="{B8D3896F-3B37-463B-899F-CD1E335C8BD0}" dt="2025-01-27T17:22:57.597" v="19" actId="1076"/>
          <ac:spMkLst>
            <pc:docMk/>
            <pc:sldMk cId="285981273" sldId="261"/>
            <ac:spMk id="37" creationId="{D8767F4B-209B-A028-3DB3-929F40E776B7}"/>
          </ac:spMkLst>
        </pc:spChg>
        <pc:spChg chg="mod">
          <ac:chgData name="Kaynak, Ahmet (kaynakat)" userId="e30822f5-f881-493f-bf88-3d523b0e27a6" providerId="ADAL" clId="{B8D3896F-3B37-463B-899F-CD1E335C8BD0}" dt="2025-01-27T17:22:57.597" v="19" actId="1076"/>
          <ac:spMkLst>
            <pc:docMk/>
            <pc:sldMk cId="285981273" sldId="261"/>
            <ac:spMk id="38" creationId="{8F96C1F7-B031-06BE-346F-70C51891AD83}"/>
          </ac:spMkLst>
        </pc:spChg>
        <pc:spChg chg="mod">
          <ac:chgData name="Kaynak, Ahmet (kaynakat)" userId="e30822f5-f881-493f-bf88-3d523b0e27a6" providerId="ADAL" clId="{B8D3896F-3B37-463B-899F-CD1E335C8BD0}" dt="2025-01-27T17:22:57.597" v="19" actId="1076"/>
          <ac:spMkLst>
            <pc:docMk/>
            <pc:sldMk cId="285981273" sldId="261"/>
            <ac:spMk id="40" creationId="{544E9F28-4B21-4E11-4832-966E0AA14D69}"/>
          </ac:spMkLst>
        </pc:spChg>
        <pc:spChg chg="mod">
          <ac:chgData name="Kaynak, Ahmet (kaynakat)" userId="e30822f5-f881-493f-bf88-3d523b0e27a6" providerId="ADAL" clId="{B8D3896F-3B37-463B-899F-CD1E335C8BD0}" dt="2025-01-27T17:22:57.597" v="19" actId="1076"/>
          <ac:spMkLst>
            <pc:docMk/>
            <pc:sldMk cId="285981273" sldId="261"/>
            <ac:spMk id="41" creationId="{C63AD719-4C9A-4EE4-9362-6AB36426CE77}"/>
          </ac:spMkLst>
        </pc:spChg>
        <pc:spChg chg="mod">
          <ac:chgData name="Kaynak, Ahmet (kaynakat)" userId="e30822f5-f881-493f-bf88-3d523b0e27a6" providerId="ADAL" clId="{B8D3896F-3B37-463B-899F-CD1E335C8BD0}" dt="2025-01-27T17:22:57.597" v="19" actId="1076"/>
          <ac:spMkLst>
            <pc:docMk/>
            <pc:sldMk cId="285981273" sldId="261"/>
            <ac:spMk id="42" creationId="{BB076DD0-E04B-3451-FBFC-898496CBEA40}"/>
          </ac:spMkLst>
        </pc:spChg>
        <pc:spChg chg="mod">
          <ac:chgData name="Kaynak, Ahmet (kaynakat)" userId="e30822f5-f881-493f-bf88-3d523b0e27a6" providerId="ADAL" clId="{B8D3896F-3B37-463B-899F-CD1E335C8BD0}" dt="2025-01-27T17:22:57.597" v="19" actId="1076"/>
          <ac:spMkLst>
            <pc:docMk/>
            <pc:sldMk cId="285981273" sldId="261"/>
            <ac:spMk id="43" creationId="{96081849-71A5-C7FC-C12A-EE61912F2897}"/>
          </ac:spMkLst>
        </pc:spChg>
        <pc:graphicFrameChg chg="modGraphic">
          <ac:chgData name="Kaynak, Ahmet (kaynakat)" userId="e30822f5-f881-493f-bf88-3d523b0e27a6" providerId="ADAL" clId="{B8D3896F-3B37-463B-899F-CD1E335C8BD0}" dt="2025-01-13T16:04:57.946" v="5" actId="14734"/>
          <ac:graphicFrameMkLst>
            <pc:docMk/>
            <pc:sldMk cId="285981273" sldId="261"/>
            <ac:graphicFrameMk id="36" creationId="{5D8E66D1-564E-3674-5131-12C284DE93D6}"/>
          </ac:graphicFrameMkLst>
        </pc:graphicFrame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1AD8B76-510C-5840-AFF8-56732EE74642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3938" y="1143000"/>
            <a:ext cx="22701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40FCF20-DC62-4C47-927D-B0873A9B05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66614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714500" y="5088045"/>
            <a:ext cx="19431000" cy="10823787"/>
          </a:xfrm>
        </p:spPr>
        <p:txBody>
          <a:bodyPr anchor="b"/>
          <a:lstStyle>
            <a:lvl1pPr algn="ctr">
              <a:defRPr sz="15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857500" y="16329239"/>
            <a:ext cx="17145000" cy="7506121"/>
          </a:xfrm>
        </p:spPr>
        <p:txBody>
          <a:bodyPr/>
          <a:lstStyle>
            <a:lvl1pPr marL="0" indent="0" algn="ctr">
              <a:buNone/>
              <a:defRPr sz="6000"/>
            </a:lvl1pPr>
            <a:lvl2pPr marL="1143000" indent="0" algn="ctr">
              <a:buNone/>
              <a:defRPr sz="5000"/>
            </a:lvl2pPr>
            <a:lvl3pPr marL="2286000" indent="0" algn="ctr">
              <a:buNone/>
              <a:defRPr sz="4500"/>
            </a:lvl3pPr>
            <a:lvl4pPr marL="3429000" indent="0" algn="ctr">
              <a:buNone/>
              <a:defRPr sz="4000"/>
            </a:lvl4pPr>
            <a:lvl5pPr marL="4572000" indent="0" algn="ctr">
              <a:buNone/>
              <a:defRPr sz="4000"/>
            </a:lvl5pPr>
            <a:lvl6pPr marL="5715000" indent="0" algn="ctr">
              <a:buNone/>
              <a:defRPr sz="4000"/>
            </a:lvl6pPr>
            <a:lvl7pPr marL="6858000" indent="0" algn="ctr">
              <a:buNone/>
              <a:defRPr sz="4000"/>
            </a:lvl7pPr>
            <a:lvl8pPr marL="8001000" indent="0" algn="ctr">
              <a:buNone/>
              <a:defRPr sz="4000"/>
            </a:lvl8pPr>
            <a:lvl9pPr marL="9144000" indent="0" algn="ctr">
              <a:buNone/>
              <a:defRPr sz="40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D5EB7-1542-4BF7-BA9D-973ECE0FEE59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5B703-010A-47A8-9FC8-8F5834A2D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4304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D5EB7-1542-4BF7-BA9D-973ECE0FEE59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5B703-010A-47A8-9FC8-8F5834A2D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96885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6359189" y="1655233"/>
            <a:ext cx="4929188" cy="2634699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571626" y="1655233"/>
            <a:ext cx="14501813" cy="2634699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D5EB7-1542-4BF7-BA9D-973ECE0FEE59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5B703-010A-47A8-9FC8-8F5834A2D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12977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D5EB7-1542-4BF7-BA9D-973ECE0FEE59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5B703-010A-47A8-9FC8-8F5834A2D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87787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59720" y="7750819"/>
            <a:ext cx="19716750" cy="12932408"/>
          </a:xfrm>
        </p:spPr>
        <p:txBody>
          <a:bodyPr anchor="b"/>
          <a:lstStyle>
            <a:lvl1pPr>
              <a:defRPr sz="15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559720" y="20805572"/>
            <a:ext cx="19716750" cy="6800848"/>
          </a:xfrm>
        </p:spPr>
        <p:txBody>
          <a:bodyPr/>
          <a:lstStyle>
            <a:lvl1pPr marL="0" indent="0">
              <a:buNone/>
              <a:defRPr sz="6000">
                <a:solidFill>
                  <a:schemeClr val="tx1"/>
                </a:solidFill>
              </a:defRPr>
            </a:lvl1pPr>
            <a:lvl2pPr marL="1143000" indent="0">
              <a:buNone/>
              <a:defRPr sz="5000">
                <a:solidFill>
                  <a:schemeClr val="tx1">
                    <a:tint val="75000"/>
                  </a:schemeClr>
                </a:solidFill>
              </a:defRPr>
            </a:lvl2pPr>
            <a:lvl3pPr marL="2286000" indent="0">
              <a:buNone/>
              <a:defRPr sz="4500">
                <a:solidFill>
                  <a:schemeClr val="tx1">
                    <a:tint val="75000"/>
                  </a:schemeClr>
                </a:solidFill>
              </a:defRPr>
            </a:lvl3pPr>
            <a:lvl4pPr marL="3429000" indent="0">
              <a:buNone/>
              <a:defRPr sz="4000">
                <a:solidFill>
                  <a:schemeClr val="tx1">
                    <a:tint val="75000"/>
                  </a:schemeClr>
                </a:solidFill>
              </a:defRPr>
            </a:lvl4pPr>
            <a:lvl5pPr marL="4572000" indent="0">
              <a:buNone/>
              <a:defRPr sz="4000">
                <a:solidFill>
                  <a:schemeClr val="tx1">
                    <a:tint val="75000"/>
                  </a:schemeClr>
                </a:solidFill>
              </a:defRPr>
            </a:lvl5pPr>
            <a:lvl6pPr marL="5715000" indent="0">
              <a:buNone/>
              <a:defRPr sz="4000">
                <a:solidFill>
                  <a:schemeClr val="tx1">
                    <a:tint val="75000"/>
                  </a:schemeClr>
                </a:solidFill>
              </a:defRPr>
            </a:lvl6pPr>
            <a:lvl7pPr marL="6858000" indent="0">
              <a:buNone/>
              <a:defRPr sz="4000">
                <a:solidFill>
                  <a:schemeClr val="tx1">
                    <a:tint val="75000"/>
                  </a:schemeClr>
                </a:solidFill>
              </a:defRPr>
            </a:lvl7pPr>
            <a:lvl8pPr marL="8001000" indent="0">
              <a:buNone/>
              <a:defRPr sz="4000">
                <a:solidFill>
                  <a:schemeClr val="tx1">
                    <a:tint val="75000"/>
                  </a:schemeClr>
                </a:solidFill>
              </a:defRPr>
            </a:lvl8pPr>
            <a:lvl9pPr marL="9144000" indent="0">
              <a:buNone/>
              <a:defRPr sz="40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D5EB7-1542-4BF7-BA9D-973ECE0FEE59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5B703-010A-47A8-9FC8-8F5834A2D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86066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571625" y="8276166"/>
            <a:ext cx="9715500" cy="197260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572875" y="8276166"/>
            <a:ext cx="9715500" cy="197260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D5EB7-1542-4BF7-BA9D-973ECE0FEE59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5B703-010A-47A8-9FC8-8F5834A2D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6319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74603" y="1655240"/>
            <a:ext cx="19716750" cy="600921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574605" y="7621272"/>
            <a:ext cx="9670850" cy="3735068"/>
          </a:xfrm>
        </p:spPr>
        <p:txBody>
          <a:bodyPr anchor="b"/>
          <a:lstStyle>
            <a:lvl1pPr marL="0" indent="0">
              <a:buNone/>
              <a:defRPr sz="6000" b="1"/>
            </a:lvl1pPr>
            <a:lvl2pPr marL="1143000" indent="0">
              <a:buNone/>
              <a:defRPr sz="5000" b="1"/>
            </a:lvl2pPr>
            <a:lvl3pPr marL="2286000" indent="0">
              <a:buNone/>
              <a:defRPr sz="4500" b="1"/>
            </a:lvl3pPr>
            <a:lvl4pPr marL="3429000" indent="0">
              <a:buNone/>
              <a:defRPr sz="4000" b="1"/>
            </a:lvl4pPr>
            <a:lvl5pPr marL="4572000" indent="0">
              <a:buNone/>
              <a:defRPr sz="4000" b="1"/>
            </a:lvl5pPr>
            <a:lvl6pPr marL="5715000" indent="0">
              <a:buNone/>
              <a:defRPr sz="4000" b="1"/>
            </a:lvl6pPr>
            <a:lvl7pPr marL="6858000" indent="0">
              <a:buNone/>
              <a:defRPr sz="4000" b="1"/>
            </a:lvl7pPr>
            <a:lvl8pPr marL="8001000" indent="0">
              <a:buNone/>
              <a:defRPr sz="4000" b="1"/>
            </a:lvl8pPr>
            <a:lvl9pPr marL="9144000" indent="0">
              <a:buNone/>
              <a:defRPr sz="40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574605" y="11356340"/>
            <a:ext cx="9670850" cy="167034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1572876" y="7621272"/>
            <a:ext cx="9718478" cy="3735068"/>
          </a:xfrm>
        </p:spPr>
        <p:txBody>
          <a:bodyPr anchor="b"/>
          <a:lstStyle>
            <a:lvl1pPr marL="0" indent="0">
              <a:buNone/>
              <a:defRPr sz="6000" b="1"/>
            </a:lvl1pPr>
            <a:lvl2pPr marL="1143000" indent="0">
              <a:buNone/>
              <a:defRPr sz="5000" b="1"/>
            </a:lvl2pPr>
            <a:lvl3pPr marL="2286000" indent="0">
              <a:buNone/>
              <a:defRPr sz="4500" b="1"/>
            </a:lvl3pPr>
            <a:lvl4pPr marL="3429000" indent="0">
              <a:buNone/>
              <a:defRPr sz="4000" b="1"/>
            </a:lvl4pPr>
            <a:lvl5pPr marL="4572000" indent="0">
              <a:buNone/>
              <a:defRPr sz="4000" b="1"/>
            </a:lvl5pPr>
            <a:lvl6pPr marL="5715000" indent="0">
              <a:buNone/>
              <a:defRPr sz="4000" b="1"/>
            </a:lvl6pPr>
            <a:lvl7pPr marL="6858000" indent="0">
              <a:buNone/>
              <a:defRPr sz="4000" b="1"/>
            </a:lvl7pPr>
            <a:lvl8pPr marL="8001000" indent="0">
              <a:buNone/>
              <a:defRPr sz="4000" b="1"/>
            </a:lvl8pPr>
            <a:lvl9pPr marL="9144000" indent="0">
              <a:buNone/>
              <a:defRPr sz="40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1572876" y="11356340"/>
            <a:ext cx="9718478" cy="167034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D5EB7-1542-4BF7-BA9D-973ECE0FEE59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5B703-010A-47A8-9FC8-8F5834A2D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49628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D5EB7-1542-4BF7-BA9D-973ECE0FEE59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5B703-010A-47A8-9FC8-8F5834A2D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61090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D5EB7-1542-4BF7-BA9D-973ECE0FEE59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5B703-010A-47A8-9FC8-8F5834A2D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54733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74603" y="2072640"/>
            <a:ext cx="7372945" cy="7254240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9718477" y="4476333"/>
            <a:ext cx="11572875" cy="22093767"/>
          </a:xfrm>
        </p:spPr>
        <p:txBody>
          <a:bodyPr/>
          <a:lstStyle>
            <a:lvl1pPr>
              <a:defRPr sz="8000"/>
            </a:lvl1pPr>
            <a:lvl2pPr>
              <a:defRPr sz="7000"/>
            </a:lvl2pPr>
            <a:lvl3pPr>
              <a:defRPr sz="6000"/>
            </a:lvl3pPr>
            <a:lvl4pPr>
              <a:defRPr sz="5000"/>
            </a:lvl4pPr>
            <a:lvl5pPr>
              <a:defRPr sz="5000"/>
            </a:lvl5pPr>
            <a:lvl6pPr>
              <a:defRPr sz="5000"/>
            </a:lvl6pPr>
            <a:lvl7pPr>
              <a:defRPr sz="5000"/>
            </a:lvl7pPr>
            <a:lvl8pPr>
              <a:defRPr sz="5000"/>
            </a:lvl8pPr>
            <a:lvl9pPr>
              <a:defRPr sz="5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574603" y="9326880"/>
            <a:ext cx="7372945" cy="17279199"/>
          </a:xfrm>
        </p:spPr>
        <p:txBody>
          <a:bodyPr/>
          <a:lstStyle>
            <a:lvl1pPr marL="0" indent="0">
              <a:buNone/>
              <a:defRPr sz="4000"/>
            </a:lvl1pPr>
            <a:lvl2pPr marL="1143000" indent="0">
              <a:buNone/>
              <a:defRPr sz="3500"/>
            </a:lvl2pPr>
            <a:lvl3pPr marL="2286000" indent="0">
              <a:buNone/>
              <a:defRPr sz="3000"/>
            </a:lvl3pPr>
            <a:lvl4pPr marL="3429000" indent="0">
              <a:buNone/>
              <a:defRPr sz="2500"/>
            </a:lvl4pPr>
            <a:lvl5pPr marL="4572000" indent="0">
              <a:buNone/>
              <a:defRPr sz="2500"/>
            </a:lvl5pPr>
            <a:lvl6pPr marL="5715000" indent="0">
              <a:buNone/>
              <a:defRPr sz="2500"/>
            </a:lvl6pPr>
            <a:lvl7pPr marL="6858000" indent="0">
              <a:buNone/>
              <a:defRPr sz="2500"/>
            </a:lvl7pPr>
            <a:lvl8pPr marL="8001000" indent="0">
              <a:buNone/>
              <a:defRPr sz="2500"/>
            </a:lvl8pPr>
            <a:lvl9pPr marL="9144000" indent="0">
              <a:buNone/>
              <a:defRPr sz="25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D5EB7-1542-4BF7-BA9D-973ECE0FEE59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5B703-010A-47A8-9FC8-8F5834A2D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68582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74603" y="2072640"/>
            <a:ext cx="7372945" cy="7254240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9718477" y="4476333"/>
            <a:ext cx="11572875" cy="22093767"/>
          </a:xfrm>
        </p:spPr>
        <p:txBody>
          <a:bodyPr anchor="t"/>
          <a:lstStyle>
            <a:lvl1pPr marL="0" indent="0">
              <a:buNone/>
              <a:defRPr sz="8000"/>
            </a:lvl1pPr>
            <a:lvl2pPr marL="1143000" indent="0">
              <a:buNone/>
              <a:defRPr sz="7000"/>
            </a:lvl2pPr>
            <a:lvl3pPr marL="2286000" indent="0">
              <a:buNone/>
              <a:defRPr sz="6000"/>
            </a:lvl3pPr>
            <a:lvl4pPr marL="3429000" indent="0">
              <a:buNone/>
              <a:defRPr sz="5000"/>
            </a:lvl4pPr>
            <a:lvl5pPr marL="4572000" indent="0">
              <a:buNone/>
              <a:defRPr sz="5000"/>
            </a:lvl5pPr>
            <a:lvl6pPr marL="5715000" indent="0">
              <a:buNone/>
              <a:defRPr sz="5000"/>
            </a:lvl6pPr>
            <a:lvl7pPr marL="6858000" indent="0">
              <a:buNone/>
              <a:defRPr sz="5000"/>
            </a:lvl7pPr>
            <a:lvl8pPr marL="8001000" indent="0">
              <a:buNone/>
              <a:defRPr sz="5000"/>
            </a:lvl8pPr>
            <a:lvl9pPr marL="9144000" indent="0">
              <a:buNone/>
              <a:defRPr sz="5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574603" y="9326880"/>
            <a:ext cx="7372945" cy="17279199"/>
          </a:xfrm>
        </p:spPr>
        <p:txBody>
          <a:bodyPr/>
          <a:lstStyle>
            <a:lvl1pPr marL="0" indent="0">
              <a:buNone/>
              <a:defRPr sz="4000"/>
            </a:lvl1pPr>
            <a:lvl2pPr marL="1143000" indent="0">
              <a:buNone/>
              <a:defRPr sz="3500"/>
            </a:lvl2pPr>
            <a:lvl3pPr marL="2286000" indent="0">
              <a:buNone/>
              <a:defRPr sz="3000"/>
            </a:lvl3pPr>
            <a:lvl4pPr marL="3429000" indent="0">
              <a:buNone/>
              <a:defRPr sz="2500"/>
            </a:lvl4pPr>
            <a:lvl5pPr marL="4572000" indent="0">
              <a:buNone/>
              <a:defRPr sz="2500"/>
            </a:lvl5pPr>
            <a:lvl6pPr marL="5715000" indent="0">
              <a:buNone/>
              <a:defRPr sz="2500"/>
            </a:lvl6pPr>
            <a:lvl7pPr marL="6858000" indent="0">
              <a:buNone/>
              <a:defRPr sz="2500"/>
            </a:lvl7pPr>
            <a:lvl8pPr marL="8001000" indent="0">
              <a:buNone/>
              <a:defRPr sz="2500"/>
            </a:lvl8pPr>
            <a:lvl9pPr marL="9144000" indent="0">
              <a:buNone/>
              <a:defRPr sz="25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D5EB7-1542-4BF7-BA9D-973ECE0FEE59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5B703-010A-47A8-9FC8-8F5834A2D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38738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571625" y="1655240"/>
            <a:ext cx="19716750" cy="600921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571625" y="8276166"/>
            <a:ext cx="19716750" cy="197260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571625" y="28815460"/>
            <a:ext cx="5143500" cy="16552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2D5EB7-1542-4BF7-BA9D-973ECE0FEE59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7572375" y="28815460"/>
            <a:ext cx="7715250" cy="16552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6144875" y="28815460"/>
            <a:ext cx="5143500" cy="16552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A5B703-010A-47A8-9FC8-8F5834A2D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17267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2286000" rtl="0" eaLnBrk="1" latinLnBrk="0" hangingPunct="1">
        <a:lnSpc>
          <a:spcPct val="90000"/>
        </a:lnSpc>
        <a:spcBef>
          <a:spcPct val="0"/>
        </a:spcBef>
        <a:buNone/>
        <a:defRPr sz="110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71500" indent="-571500" algn="l" defTabSz="2286000" rtl="0" eaLnBrk="1" latinLnBrk="0" hangingPunct="1">
        <a:lnSpc>
          <a:spcPct val="90000"/>
        </a:lnSpc>
        <a:spcBef>
          <a:spcPts val="2500"/>
        </a:spcBef>
        <a:buFont typeface="Arial" panose="020B0604020202020204" pitchFamily="34" charset="0"/>
        <a:buChar char="•"/>
        <a:defRPr sz="7000" kern="1200">
          <a:solidFill>
            <a:schemeClr val="tx1"/>
          </a:solidFill>
          <a:latin typeface="+mn-lt"/>
          <a:ea typeface="+mn-ea"/>
          <a:cs typeface="+mn-cs"/>
        </a:defRPr>
      </a:lvl1pPr>
      <a:lvl2pPr marL="1714500" indent="-571500" algn="l" defTabSz="2286000" rtl="0" eaLnBrk="1" latinLnBrk="0" hangingPunct="1">
        <a:lnSpc>
          <a:spcPct val="90000"/>
        </a:lnSpc>
        <a:spcBef>
          <a:spcPts val="1250"/>
        </a:spcBef>
        <a:buFont typeface="Arial" panose="020B0604020202020204" pitchFamily="34" charset="0"/>
        <a:buChar char="•"/>
        <a:defRPr sz="6000" kern="1200">
          <a:solidFill>
            <a:schemeClr val="tx1"/>
          </a:solidFill>
          <a:latin typeface="+mn-lt"/>
          <a:ea typeface="+mn-ea"/>
          <a:cs typeface="+mn-cs"/>
        </a:defRPr>
      </a:lvl2pPr>
      <a:lvl3pPr marL="2857500" indent="-571500" algn="l" defTabSz="2286000" rtl="0" eaLnBrk="1" latinLnBrk="0" hangingPunct="1">
        <a:lnSpc>
          <a:spcPct val="90000"/>
        </a:lnSpc>
        <a:spcBef>
          <a:spcPts val="1250"/>
        </a:spcBef>
        <a:buFont typeface="Arial" panose="020B0604020202020204" pitchFamily="34" charset="0"/>
        <a:buChar char="•"/>
        <a:defRPr sz="5000" kern="1200">
          <a:solidFill>
            <a:schemeClr val="tx1"/>
          </a:solidFill>
          <a:latin typeface="+mn-lt"/>
          <a:ea typeface="+mn-ea"/>
          <a:cs typeface="+mn-cs"/>
        </a:defRPr>
      </a:lvl3pPr>
      <a:lvl4pPr marL="4000500" indent="-571500" algn="l" defTabSz="2286000" rtl="0" eaLnBrk="1" latinLnBrk="0" hangingPunct="1">
        <a:lnSpc>
          <a:spcPct val="90000"/>
        </a:lnSpc>
        <a:spcBef>
          <a:spcPts val="1250"/>
        </a:spcBef>
        <a:buFont typeface="Arial" panose="020B0604020202020204" pitchFamily="34" charset="0"/>
        <a:buChar char="•"/>
        <a:defRPr sz="4500" kern="1200">
          <a:solidFill>
            <a:schemeClr val="tx1"/>
          </a:solidFill>
          <a:latin typeface="+mn-lt"/>
          <a:ea typeface="+mn-ea"/>
          <a:cs typeface="+mn-cs"/>
        </a:defRPr>
      </a:lvl4pPr>
      <a:lvl5pPr marL="5143500" indent="-571500" algn="l" defTabSz="2286000" rtl="0" eaLnBrk="1" latinLnBrk="0" hangingPunct="1">
        <a:lnSpc>
          <a:spcPct val="90000"/>
        </a:lnSpc>
        <a:spcBef>
          <a:spcPts val="1250"/>
        </a:spcBef>
        <a:buFont typeface="Arial" panose="020B0604020202020204" pitchFamily="34" charset="0"/>
        <a:buChar char="•"/>
        <a:defRPr sz="4500" kern="1200">
          <a:solidFill>
            <a:schemeClr val="tx1"/>
          </a:solidFill>
          <a:latin typeface="+mn-lt"/>
          <a:ea typeface="+mn-ea"/>
          <a:cs typeface="+mn-cs"/>
        </a:defRPr>
      </a:lvl5pPr>
      <a:lvl6pPr marL="6286500" indent="-571500" algn="l" defTabSz="2286000" rtl="0" eaLnBrk="1" latinLnBrk="0" hangingPunct="1">
        <a:lnSpc>
          <a:spcPct val="90000"/>
        </a:lnSpc>
        <a:spcBef>
          <a:spcPts val="1250"/>
        </a:spcBef>
        <a:buFont typeface="Arial" panose="020B0604020202020204" pitchFamily="34" charset="0"/>
        <a:buChar char="•"/>
        <a:defRPr sz="4500" kern="1200">
          <a:solidFill>
            <a:schemeClr val="tx1"/>
          </a:solidFill>
          <a:latin typeface="+mn-lt"/>
          <a:ea typeface="+mn-ea"/>
          <a:cs typeface="+mn-cs"/>
        </a:defRPr>
      </a:lvl6pPr>
      <a:lvl7pPr marL="7429500" indent="-571500" algn="l" defTabSz="2286000" rtl="0" eaLnBrk="1" latinLnBrk="0" hangingPunct="1">
        <a:lnSpc>
          <a:spcPct val="90000"/>
        </a:lnSpc>
        <a:spcBef>
          <a:spcPts val="1250"/>
        </a:spcBef>
        <a:buFont typeface="Arial" panose="020B0604020202020204" pitchFamily="34" charset="0"/>
        <a:buChar char="•"/>
        <a:defRPr sz="4500" kern="1200">
          <a:solidFill>
            <a:schemeClr val="tx1"/>
          </a:solidFill>
          <a:latin typeface="+mn-lt"/>
          <a:ea typeface="+mn-ea"/>
          <a:cs typeface="+mn-cs"/>
        </a:defRPr>
      </a:lvl7pPr>
      <a:lvl8pPr marL="8572500" indent="-571500" algn="l" defTabSz="2286000" rtl="0" eaLnBrk="1" latinLnBrk="0" hangingPunct="1">
        <a:lnSpc>
          <a:spcPct val="90000"/>
        </a:lnSpc>
        <a:spcBef>
          <a:spcPts val="1250"/>
        </a:spcBef>
        <a:buFont typeface="Arial" panose="020B0604020202020204" pitchFamily="34" charset="0"/>
        <a:buChar char="•"/>
        <a:defRPr sz="4500" kern="1200">
          <a:solidFill>
            <a:schemeClr val="tx1"/>
          </a:solidFill>
          <a:latin typeface="+mn-lt"/>
          <a:ea typeface="+mn-ea"/>
          <a:cs typeface="+mn-cs"/>
        </a:defRPr>
      </a:lvl8pPr>
      <a:lvl9pPr marL="9715500" indent="-571500" algn="l" defTabSz="2286000" rtl="0" eaLnBrk="1" latinLnBrk="0" hangingPunct="1">
        <a:lnSpc>
          <a:spcPct val="90000"/>
        </a:lnSpc>
        <a:spcBef>
          <a:spcPts val="1250"/>
        </a:spcBef>
        <a:buFont typeface="Arial" panose="020B0604020202020204" pitchFamily="34" charset="0"/>
        <a:buChar char="•"/>
        <a:defRPr sz="4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286000" rtl="0" eaLnBrk="1" latinLnBrk="0" hangingPunct="1">
        <a:defRPr sz="4500" kern="1200">
          <a:solidFill>
            <a:schemeClr val="tx1"/>
          </a:solidFill>
          <a:latin typeface="+mn-lt"/>
          <a:ea typeface="+mn-ea"/>
          <a:cs typeface="+mn-cs"/>
        </a:defRPr>
      </a:lvl1pPr>
      <a:lvl2pPr marL="1143000" algn="l" defTabSz="2286000" rtl="0" eaLnBrk="1" latinLnBrk="0" hangingPunct="1">
        <a:defRPr sz="4500" kern="1200">
          <a:solidFill>
            <a:schemeClr val="tx1"/>
          </a:solidFill>
          <a:latin typeface="+mn-lt"/>
          <a:ea typeface="+mn-ea"/>
          <a:cs typeface="+mn-cs"/>
        </a:defRPr>
      </a:lvl2pPr>
      <a:lvl3pPr marL="2286000" algn="l" defTabSz="2286000" rtl="0" eaLnBrk="1" latinLnBrk="0" hangingPunct="1">
        <a:defRPr sz="4500" kern="1200">
          <a:solidFill>
            <a:schemeClr val="tx1"/>
          </a:solidFill>
          <a:latin typeface="+mn-lt"/>
          <a:ea typeface="+mn-ea"/>
          <a:cs typeface="+mn-cs"/>
        </a:defRPr>
      </a:lvl3pPr>
      <a:lvl4pPr marL="3429000" algn="l" defTabSz="2286000" rtl="0" eaLnBrk="1" latinLnBrk="0" hangingPunct="1">
        <a:defRPr sz="4500" kern="1200">
          <a:solidFill>
            <a:schemeClr val="tx1"/>
          </a:solidFill>
          <a:latin typeface="+mn-lt"/>
          <a:ea typeface="+mn-ea"/>
          <a:cs typeface="+mn-cs"/>
        </a:defRPr>
      </a:lvl4pPr>
      <a:lvl5pPr marL="4572000" algn="l" defTabSz="2286000" rtl="0" eaLnBrk="1" latinLnBrk="0" hangingPunct="1">
        <a:defRPr sz="4500" kern="1200">
          <a:solidFill>
            <a:schemeClr val="tx1"/>
          </a:solidFill>
          <a:latin typeface="+mn-lt"/>
          <a:ea typeface="+mn-ea"/>
          <a:cs typeface="+mn-cs"/>
        </a:defRPr>
      </a:lvl5pPr>
      <a:lvl6pPr marL="5715000" algn="l" defTabSz="2286000" rtl="0" eaLnBrk="1" latinLnBrk="0" hangingPunct="1">
        <a:defRPr sz="4500" kern="1200">
          <a:solidFill>
            <a:schemeClr val="tx1"/>
          </a:solidFill>
          <a:latin typeface="+mn-lt"/>
          <a:ea typeface="+mn-ea"/>
          <a:cs typeface="+mn-cs"/>
        </a:defRPr>
      </a:lvl6pPr>
      <a:lvl7pPr marL="6858000" algn="l" defTabSz="2286000" rtl="0" eaLnBrk="1" latinLnBrk="0" hangingPunct="1">
        <a:defRPr sz="4500" kern="1200">
          <a:solidFill>
            <a:schemeClr val="tx1"/>
          </a:solidFill>
          <a:latin typeface="+mn-lt"/>
          <a:ea typeface="+mn-ea"/>
          <a:cs typeface="+mn-cs"/>
        </a:defRPr>
      </a:lvl7pPr>
      <a:lvl8pPr marL="8001000" algn="l" defTabSz="2286000" rtl="0" eaLnBrk="1" latinLnBrk="0" hangingPunct="1">
        <a:defRPr sz="4500" kern="1200">
          <a:solidFill>
            <a:schemeClr val="tx1"/>
          </a:solidFill>
          <a:latin typeface="+mn-lt"/>
          <a:ea typeface="+mn-ea"/>
          <a:cs typeface="+mn-cs"/>
        </a:defRPr>
      </a:lvl8pPr>
      <a:lvl9pPr marL="9144000" algn="l" defTabSz="2286000" rtl="0" eaLnBrk="1" latinLnBrk="0" hangingPunct="1">
        <a:defRPr sz="45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jpeg"/><Relationship Id="rId5" Type="http://schemas.microsoft.com/office/2007/relationships/hdphoto" Target="../media/hdphoto2.wdp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7C5DA2C-4FA4-4A1B-3888-DBC08B576E3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extBox 17">
            <a:extLst>
              <a:ext uri="{FF2B5EF4-FFF2-40B4-BE49-F238E27FC236}">
                <a16:creationId xmlns:a16="http://schemas.microsoft.com/office/drawing/2014/main" id="{9CE66A8D-058D-3B13-CE63-2BDBA44AA9C7}"/>
              </a:ext>
            </a:extLst>
          </p:cNvPr>
          <p:cNvSpPr txBox="1"/>
          <p:nvPr/>
        </p:nvSpPr>
        <p:spPr>
          <a:xfrm>
            <a:off x="686059" y="26814329"/>
            <a:ext cx="21487879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ure S2: Human cytokine array in response to Gli36 EMD-CMs. </a:t>
            </a:r>
            <a:r>
              <a:rPr lang="en-US" sz="28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Human cytokine array profile showing cytokine profiles from culture supernatants obtained from THP-1 cells cultured with DMEM (</a:t>
            </a:r>
            <a:r>
              <a:rPr lang="en-US" sz="2800" b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top</a:t>
            </a:r>
            <a:r>
              <a:rPr lang="en-US" sz="28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 panel), cytokine profile from Gli36 EMD-CM (</a:t>
            </a:r>
            <a:r>
              <a:rPr lang="en-US" sz="2800" b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middle left </a:t>
            </a:r>
            <a:r>
              <a:rPr lang="en-US" sz="28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panel) and from THP-1 cells cultured with Gli36 EMD-CM (</a:t>
            </a:r>
            <a:r>
              <a:rPr lang="en-US" sz="2800" b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middle right </a:t>
            </a:r>
            <a:r>
              <a:rPr lang="en-US" sz="28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panel). Table showing total array protein studied with highlighted M1 (Red) and M2 (Blue) cytokines (bottom panel).  </a:t>
            </a:r>
            <a:endParaRPr 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E3AB56F4-BD54-3304-2F98-1E8D5FF502F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duotone>
              <a:prstClr val="black"/>
              <a:schemeClr val="tx2"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46000"/>
                    </a14:imgEffect>
                    <a14:imgEffect>
                      <a14:colorTemperature colorTemp="4700"/>
                    </a14:imgEffect>
                    <a14:imgEffect>
                      <a14:saturation sat="0"/>
                    </a14:imgEffect>
                    <a14:imgEffect>
                      <a14:brightnessContrast bright="61000" contrast="58000"/>
                    </a14:imgEffect>
                  </a14:imgLayer>
                </a14:imgProps>
              </a:ext>
            </a:extLst>
          </a:blip>
          <a:srcRect l="64366" t="11571" r="11047" b="82284"/>
          <a:stretch/>
        </p:blipFill>
        <p:spPr>
          <a:xfrm flipV="1">
            <a:off x="8010997" y="7482265"/>
            <a:ext cx="6007820" cy="1893784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F57F2BEB-9D61-8B0D-6C84-3DDFBCF70897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39000"/>
                    </a14:imgEffect>
                    <a14:imgEffect>
                      <a14:saturation sat="0"/>
                    </a14:imgEffect>
                    <a14:imgEffect>
                      <a14:brightnessContrast bright="57000" contrast="30000"/>
                    </a14:imgEffect>
                  </a14:imgLayer>
                </a14:imgProps>
              </a:ext>
            </a:extLst>
          </a:blip>
          <a:srcRect l="64366" t="19931" r="12742" b="74157"/>
          <a:stretch/>
        </p:blipFill>
        <p:spPr>
          <a:xfrm flipV="1">
            <a:off x="10952544" y="10098832"/>
            <a:ext cx="5999974" cy="1954271"/>
          </a:xfrm>
          <a:prstGeom prst="rect">
            <a:avLst/>
          </a:prstGeom>
        </p:spPr>
      </p:pic>
      <p:sp>
        <p:nvSpPr>
          <p:cNvPr id="29" name="Rectangle 28">
            <a:extLst>
              <a:ext uri="{FF2B5EF4-FFF2-40B4-BE49-F238E27FC236}">
                <a16:creationId xmlns:a16="http://schemas.microsoft.com/office/drawing/2014/main" id="{F42B4A5F-09E1-1CA7-DC99-4C350DF435DC}"/>
              </a:ext>
            </a:extLst>
          </p:cNvPr>
          <p:cNvSpPr/>
          <p:nvPr/>
        </p:nvSpPr>
        <p:spPr>
          <a:xfrm>
            <a:off x="15721863" y="9460650"/>
            <a:ext cx="1935145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Gli36 EMD-CM </a:t>
            </a:r>
            <a:r>
              <a:rPr lang="en-US" sz="2000" b="1">
                <a:latin typeface="Arial" panose="020B0604020202020204" pitchFamily="34" charset="0"/>
                <a:cs typeface="Arial" panose="020B0604020202020204" pitchFamily="34" charset="0"/>
              </a:rPr>
              <a:t>+THP-1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F026F0A9-669B-B7EA-8FFD-EE5446FD80CF}"/>
              </a:ext>
            </a:extLst>
          </p:cNvPr>
          <p:cNvSpPr/>
          <p:nvPr/>
        </p:nvSpPr>
        <p:spPr>
          <a:xfrm>
            <a:off x="12674288" y="7102499"/>
            <a:ext cx="1667444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THP-1 alone</a:t>
            </a:r>
          </a:p>
        </p:txBody>
      </p:sp>
      <p:grpSp>
        <p:nvGrpSpPr>
          <p:cNvPr id="32" name="Group 31">
            <a:extLst>
              <a:ext uri="{FF2B5EF4-FFF2-40B4-BE49-F238E27FC236}">
                <a16:creationId xmlns:a16="http://schemas.microsoft.com/office/drawing/2014/main" id="{F1A985BA-4491-3896-4C2B-0AA7665637C9}"/>
              </a:ext>
            </a:extLst>
          </p:cNvPr>
          <p:cNvGrpSpPr/>
          <p:nvPr/>
        </p:nvGrpSpPr>
        <p:grpSpPr>
          <a:xfrm>
            <a:off x="4844423" y="10099871"/>
            <a:ext cx="6007820" cy="2022615"/>
            <a:chOff x="152639" y="2296279"/>
            <a:chExt cx="6109553" cy="2110499"/>
          </a:xfrm>
        </p:grpSpPr>
        <p:sp>
          <p:nvSpPr>
            <p:cNvPr id="33" name="Rectangle 32">
              <a:extLst>
                <a:ext uri="{FF2B5EF4-FFF2-40B4-BE49-F238E27FC236}">
                  <a16:creationId xmlns:a16="http://schemas.microsoft.com/office/drawing/2014/main" id="{DAA2A1CD-35B0-1BFC-CA52-061FCF3A1C86}"/>
                </a:ext>
              </a:extLst>
            </p:cNvPr>
            <p:cNvSpPr/>
            <p:nvPr/>
          </p:nvSpPr>
          <p:spPr>
            <a:xfrm>
              <a:off x="1703652" y="2942376"/>
              <a:ext cx="1030580" cy="41749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CXCL1</a:t>
              </a:r>
            </a:p>
          </p:txBody>
        </p:sp>
        <p:pic>
          <p:nvPicPr>
            <p:cNvPr id="34" name="Picture 3">
              <a:extLst>
                <a:ext uri="{FF2B5EF4-FFF2-40B4-BE49-F238E27FC236}">
                  <a16:creationId xmlns:a16="http://schemas.microsoft.com/office/drawing/2014/main" id="{4C1FA902-712C-5E3F-1238-FD3C3EAA0C89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saturation sat="0"/>
                      </a14:imgEffect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438" t="21049" r="23972" b="72942"/>
            <a:stretch/>
          </p:blipFill>
          <p:spPr bwMode="auto">
            <a:xfrm flipH="1">
              <a:off x="152639" y="2296279"/>
              <a:ext cx="6109553" cy="21104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sp>
        <p:nvSpPr>
          <p:cNvPr id="35" name="Rectangle 34">
            <a:extLst>
              <a:ext uri="{FF2B5EF4-FFF2-40B4-BE49-F238E27FC236}">
                <a16:creationId xmlns:a16="http://schemas.microsoft.com/office/drawing/2014/main" id="{10738D71-9A2F-6448-FC18-A2DDCD9BEF70}"/>
              </a:ext>
            </a:extLst>
          </p:cNvPr>
          <p:cNvSpPr/>
          <p:nvPr/>
        </p:nvSpPr>
        <p:spPr>
          <a:xfrm>
            <a:off x="9780424" y="9710876"/>
            <a:ext cx="1935145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Gli36 EMD-CM</a:t>
            </a:r>
          </a:p>
        </p:txBody>
      </p:sp>
      <p:graphicFrame>
        <p:nvGraphicFramePr>
          <p:cNvPr id="36" name="Table 132">
            <a:extLst>
              <a:ext uri="{FF2B5EF4-FFF2-40B4-BE49-F238E27FC236}">
                <a16:creationId xmlns:a16="http://schemas.microsoft.com/office/drawing/2014/main" id="{5D8E66D1-564E-3674-5131-12C284DE93D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30225552"/>
              </p:ext>
            </p:extLst>
          </p:nvPr>
        </p:nvGraphicFramePr>
        <p:xfrm>
          <a:off x="896009" y="12920051"/>
          <a:ext cx="19633629" cy="4008884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19877">
                  <a:extLst>
                    <a:ext uri="{9D8B030D-6E8A-4147-A177-3AD203B41FA5}">
                      <a16:colId xmlns:a16="http://schemas.microsoft.com/office/drawing/2014/main" val="1531276491"/>
                    </a:ext>
                  </a:extLst>
                </a:gridCol>
                <a:gridCol w="619877">
                  <a:extLst>
                    <a:ext uri="{9D8B030D-6E8A-4147-A177-3AD203B41FA5}">
                      <a16:colId xmlns:a16="http://schemas.microsoft.com/office/drawing/2014/main" val="428890881"/>
                    </a:ext>
                  </a:extLst>
                </a:gridCol>
                <a:gridCol w="987998">
                  <a:extLst>
                    <a:ext uri="{9D8B030D-6E8A-4147-A177-3AD203B41FA5}">
                      <a16:colId xmlns:a16="http://schemas.microsoft.com/office/drawing/2014/main" val="3039113411"/>
                    </a:ext>
                  </a:extLst>
                </a:gridCol>
                <a:gridCol w="987998">
                  <a:extLst>
                    <a:ext uri="{9D8B030D-6E8A-4147-A177-3AD203B41FA5}">
                      <a16:colId xmlns:a16="http://schemas.microsoft.com/office/drawing/2014/main" val="2453334111"/>
                    </a:ext>
                  </a:extLst>
                </a:gridCol>
                <a:gridCol w="1166056">
                  <a:extLst>
                    <a:ext uri="{9D8B030D-6E8A-4147-A177-3AD203B41FA5}">
                      <a16:colId xmlns:a16="http://schemas.microsoft.com/office/drawing/2014/main" val="2001225931"/>
                    </a:ext>
                  </a:extLst>
                </a:gridCol>
                <a:gridCol w="1166056">
                  <a:extLst>
                    <a:ext uri="{9D8B030D-6E8A-4147-A177-3AD203B41FA5}">
                      <a16:colId xmlns:a16="http://schemas.microsoft.com/office/drawing/2014/main" val="2465023547"/>
                    </a:ext>
                  </a:extLst>
                </a:gridCol>
                <a:gridCol w="972574">
                  <a:extLst>
                    <a:ext uri="{9D8B030D-6E8A-4147-A177-3AD203B41FA5}">
                      <a16:colId xmlns:a16="http://schemas.microsoft.com/office/drawing/2014/main" val="2662833848"/>
                    </a:ext>
                  </a:extLst>
                </a:gridCol>
                <a:gridCol w="972574">
                  <a:extLst>
                    <a:ext uri="{9D8B030D-6E8A-4147-A177-3AD203B41FA5}">
                      <a16:colId xmlns:a16="http://schemas.microsoft.com/office/drawing/2014/main" val="825963380"/>
                    </a:ext>
                  </a:extLst>
                </a:gridCol>
                <a:gridCol w="1230550">
                  <a:extLst>
                    <a:ext uri="{9D8B030D-6E8A-4147-A177-3AD203B41FA5}">
                      <a16:colId xmlns:a16="http://schemas.microsoft.com/office/drawing/2014/main" val="3844814057"/>
                    </a:ext>
                  </a:extLst>
                </a:gridCol>
                <a:gridCol w="1197455">
                  <a:extLst>
                    <a:ext uri="{9D8B030D-6E8A-4147-A177-3AD203B41FA5}">
                      <a16:colId xmlns:a16="http://schemas.microsoft.com/office/drawing/2014/main" val="1493381781"/>
                    </a:ext>
                  </a:extLst>
                </a:gridCol>
                <a:gridCol w="844517">
                  <a:extLst>
                    <a:ext uri="{9D8B030D-6E8A-4147-A177-3AD203B41FA5}">
                      <a16:colId xmlns:a16="http://schemas.microsoft.com/office/drawing/2014/main" val="3433656950"/>
                    </a:ext>
                  </a:extLst>
                </a:gridCol>
                <a:gridCol w="888365">
                  <a:extLst>
                    <a:ext uri="{9D8B030D-6E8A-4147-A177-3AD203B41FA5}">
                      <a16:colId xmlns:a16="http://schemas.microsoft.com/office/drawing/2014/main" val="536037371"/>
                    </a:ext>
                  </a:extLst>
                </a:gridCol>
                <a:gridCol w="976228">
                  <a:extLst>
                    <a:ext uri="{9D8B030D-6E8A-4147-A177-3AD203B41FA5}">
                      <a16:colId xmlns:a16="http://schemas.microsoft.com/office/drawing/2014/main" val="2276649032"/>
                    </a:ext>
                  </a:extLst>
                </a:gridCol>
                <a:gridCol w="976228">
                  <a:extLst>
                    <a:ext uri="{9D8B030D-6E8A-4147-A177-3AD203B41FA5}">
                      <a16:colId xmlns:a16="http://schemas.microsoft.com/office/drawing/2014/main" val="2029079155"/>
                    </a:ext>
                  </a:extLst>
                </a:gridCol>
                <a:gridCol w="1163462">
                  <a:extLst>
                    <a:ext uri="{9D8B030D-6E8A-4147-A177-3AD203B41FA5}">
                      <a16:colId xmlns:a16="http://schemas.microsoft.com/office/drawing/2014/main" val="4282939283"/>
                    </a:ext>
                  </a:extLst>
                </a:gridCol>
                <a:gridCol w="1200150">
                  <a:extLst>
                    <a:ext uri="{9D8B030D-6E8A-4147-A177-3AD203B41FA5}">
                      <a16:colId xmlns:a16="http://schemas.microsoft.com/office/drawing/2014/main" val="1434151939"/>
                    </a:ext>
                  </a:extLst>
                </a:gridCol>
                <a:gridCol w="939679">
                  <a:extLst>
                    <a:ext uri="{9D8B030D-6E8A-4147-A177-3AD203B41FA5}">
                      <a16:colId xmlns:a16="http://schemas.microsoft.com/office/drawing/2014/main" val="3900638974"/>
                    </a:ext>
                  </a:extLst>
                </a:gridCol>
                <a:gridCol w="1237732">
                  <a:extLst>
                    <a:ext uri="{9D8B030D-6E8A-4147-A177-3AD203B41FA5}">
                      <a16:colId xmlns:a16="http://schemas.microsoft.com/office/drawing/2014/main" val="188059635"/>
                    </a:ext>
                  </a:extLst>
                </a:gridCol>
                <a:gridCol w="687629">
                  <a:extLst>
                    <a:ext uri="{9D8B030D-6E8A-4147-A177-3AD203B41FA5}">
                      <a16:colId xmlns:a16="http://schemas.microsoft.com/office/drawing/2014/main" val="3343087340"/>
                    </a:ext>
                  </a:extLst>
                </a:gridCol>
                <a:gridCol w="798624">
                  <a:extLst>
                    <a:ext uri="{9D8B030D-6E8A-4147-A177-3AD203B41FA5}">
                      <a16:colId xmlns:a16="http://schemas.microsoft.com/office/drawing/2014/main" val="632335207"/>
                    </a:ext>
                  </a:extLst>
                </a:gridCol>
              </a:tblGrid>
              <a:tr h="805190"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f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f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5/C5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5/C5a</a:t>
                      </a:r>
                    </a:p>
                    <a:p>
                      <a:endParaRPr lang="en-US" sz="1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 4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 4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-CSF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1828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-CSF</a:t>
                      </a:r>
                    </a:p>
                    <a:p>
                      <a:endParaRPr lang="en-US" sz="1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M-GSF</a:t>
                      </a:r>
                    </a:p>
                  </a:txBody>
                  <a:tcPr>
                    <a:solidFill>
                      <a:srgbClr val="FF33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1828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M-GSF</a:t>
                      </a:r>
                    </a:p>
                    <a:p>
                      <a:endParaRPr lang="en-US" sz="18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FF3300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O</a:t>
                      </a:r>
                      <a:r>
                        <a:rPr lang="el-GR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</a:t>
                      </a:r>
                      <a:endParaRPr lang="en-US" sz="1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1828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O</a:t>
                      </a:r>
                      <a:r>
                        <a:rPr lang="el-GR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</a:t>
                      </a:r>
                      <a:endParaRPr lang="en-US" sz="1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endParaRPr lang="en-US" sz="1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-30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1828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-309</a:t>
                      </a:r>
                    </a:p>
                    <a:p>
                      <a:endParaRPr lang="en-US" sz="1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CAM-1</a:t>
                      </a:r>
                    </a:p>
                  </a:txBody>
                  <a:tcPr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1828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CAM-1</a:t>
                      </a:r>
                    </a:p>
                    <a:p>
                      <a:endParaRPr lang="en-US" sz="18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FN-</a:t>
                      </a:r>
                      <a:r>
                        <a:rPr lang="el-GR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ϒ</a:t>
                      </a:r>
                      <a:endParaRPr lang="en-US" sz="1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1828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FN-</a:t>
                      </a:r>
                      <a:r>
                        <a:rPr lang="el-GR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ϒ</a:t>
                      </a:r>
                      <a:endParaRPr lang="en-US" sz="1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endParaRPr lang="en-US" sz="1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f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f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83749156"/>
                  </a:ext>
                </a:extLst>
              </a:tr>
              <a:tr h="659585">
                <a:tc>
                  <a:txBody>
                    <a:bodyPr/>
                    <a:lstStyle/>
                    <a:p>
                      <a:endParaRPr lang="en-US" sz="1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1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1</a:t>
                      </a:r>
                      <a:r>
                        <a:rPr lang="el-GR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</a:t>
                      </a:r>
                      <a:endParaRPr lang="en-US" sz="1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FF33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1828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1</a:t>
                      </a:r>
                      <a:r>
                        <a:rPr lang="el-GR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</a:t>
                      </a:r>
                      <a:endParaRPr lang="en-US" sz="1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endParaRPr lang="en-US" sz="1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FF3300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1</a:t>
                      </a:r>
                      <a:r>
                        <a:rPr lang="el-GR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β</a:t>
                      </a:r>
                      <a:endParaRPr lang="en-US" sz="1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FF33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1828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1</a:t>
                      </a:r>
                      <a:r>
                        <a:rPr lang="el-GR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β</a:t>
                      </a:r>
                      <a:endParaRPr lang="en-US" sz="1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endParaRPr lang="en-US" sz="1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FF3300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1ra</a:t>
                      </a:r>
                    </a:p>
                  </a:txBody>
                  <a:tcPr>
                    <a:solidFill>
                      <a:srgbClr val="FF33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1828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1ra</a:t>
                      </a:r>
                    </a:p>
                    <a:p>
                      <a:endParaRPr lang="en-US" sz="1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FF3300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1828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2</a:t>
                      </a:r>
                    </a:p>
                    <a:p>
                      <a:endParaRPr lang="en-US" sz="1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1828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4</a:t>
                      </a:r>
                    </a:p>
                    <a:p>
                      <a:endParaRPr lang="en-US" sz="1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1828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5</a:t>
                      </a:r>
                    </a:p>
                    <a:p>
                      <a:endParaRPr lang="en-US" sz="1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6</a:t>
                      </a:r>
                    </a:p>
                  </a:txBody>
                  <a:tcPr>
                    <a:solidFill>
                      <a:srgbClr val="FF33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1828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6</a:t>
                      </a:r>
                    </a:p>
                    <a:p>
                      <a:endParaRPr lang="en-US" sz="1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FF3300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8</a:t>
                      </a:r>
                    </a:p>
                  </a:txBody>
                  <a:tcP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1828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8</a:t>
                      </a:r>
                    </a:p>
                    <a:p>
                      <a:endParaRPr lang="en-US" sz="1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07884147"/>
                  </a:ext>
                </a:extLst>
              </a:tr>
              <a:tr h="942262">
                <a:tc>
                  <a:txBody>
                    <a:bodyPr/>
                    <a:lstStyle/>
                    <a:p>
                      <a:endParaRPr lang="en-US" sz="1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1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1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1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12p7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1828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12p70</a:t>
                      </a:r>
                    </a:p>
                    <a:p>
                      <a:endParaRPr lang="en-US" sz="1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1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1828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13</a:t>
                      </a:r>
                    </a:p>
                    <a:p>
                      <a:endParaRPr lang="en-US" sz="1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1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1828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16</a:t>
                      </a:r>
                    </a:p>
                    <a:p>
                      <a:endParaRPr lang="en-US" sz="1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1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1828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17</a:t>
                      </a:r>
                    </a:p>
                    <a:p>
                      <a:endParaRPr lang="en-US" sz="1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17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1828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17E</a:t>
                      </a:r>
                    </a:p>
                    <a:p>
                      <a:endParaRPr lang="en-US" sz="1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2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2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2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1828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27</a:t>
                      </a:r>
                    </a:p>
                    <a:p>
                      <a:endParaRPr lang="en-US" sz="1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1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1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79031167"/>
                  </a:ext>
                </a:extLst>
              </a:tr>
              <a:tr h="942262">
                <a:tc>
                  <a:txBody>
                    <a:bodyPr/>
                    <a:lstStyle/>
                    <a:p>
                      <a:endParaRPr lang="en-US" sz="1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1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1828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32</a:t>
                      </a:r>
                      <a:r>
                        <a:rPr lang="el-GR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</a:t>
                      </a:r>
                      <a:endParaRPr lang="en-US" sz="1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endParaRPr lang="en-US" sz="1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1828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32</a:t>
                      </a:r>
                      <a:r>
                        <a:rPr lang="el-GR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</a:t>
                      </a:r>
                      <a:endParaRPr lang="en-US" sz="1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endParaRPr lang="en-US" sz="1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P-1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1828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P-10</a:t>
                      </a:r>
                    </a:p>
                    <a:p>
                      <a:endParaRPr lang="en-US" sz="1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-TAC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1828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-TAC</a:t>
                      </a:r>
                    </a:p>
                    <a:p>
                      <a:endParaRPr lang="en-US" sz="1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CP-1</a:t>
                      </a:r>
                    </a:p>
                  </a:txBody>
                  <a:tcPr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1828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CP-1</a:t>
                      </a:r>
                    </a:p>
                    <a:p>
                      <a:endParaRPr lang="en-US" sz="1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F</a:t>
                      </a:r>
                    </a:p>
                  </a:txBody>
                  <a:tcPr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1828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F</a:t>
                      </a:r>
                    </a:p>
                    <a:p>
                      <a:endParaRPr lang="en-US" sz="1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1828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P-1</a:t>
                      </a:r>
                      <a:r>
                        <a:rPr lang="el-GR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</a:t>
                      </a:r>
                      <a:endParaRPr lang="en-US" sz="1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endParaRPr lang="en-US" sz="1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1828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P-1</a:t>
                      </a:r>
                      <a:r>
                        <a:rPr lang="el-GR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</a:t>
                      </a:r>
                      <a:endParaRPr lang="en-US" sz="1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endParaRPr lang="en-US" sz="1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1828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P-1</a:t>
                      </a:r>
                      <a:r>
                        <a:rPr lang="el-GR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β</a:t>
                      </a:r>
                      <a:endParaRPr lang="en-US" sz="1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l" defTabSz="1828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endParaRPr lang="en-US" sz="1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1828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P-1</a:t>
                      </a:r>
                      <a:r>
                        <a:rPr lang="el-GR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β</a:t>
                      </a:r>
                      <a:endParaRPr lang="en-US" sz="1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endParaRPr lang="en-US" sz="1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pin E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1828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pin E1</a:t>
                      </a:r>
                    </a:p>
                    <a:p>
                      <a:endParaRPr lang="en-US" sz="1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1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1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33358444"/>
                  </a:ext>
                </a:extLst>
              </a:tr>
              <a:tr h="659585"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f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f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1828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CL5</a:t>
                      </a:r>
                      <a:endParaRPr kumimoji="0" lang="en-US" sz="1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1828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CL5</a:t>
                      </a:r>
                    </a:p>
                  </a:txBody>
                  <a:tcPr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F-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1828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F-1</a:t>
                      </a:r>
                    </a:p>
                    <a:p>
                      <a:endParaRPr lang="en-US" sz="1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1828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NF-</a:t>
                      </a:r>
                      <a:r>
                        <a:rPr lang="el-GR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</a:t>
                      </a:r>
                      <a:endParaRPr lang="en-US" sz="1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endParaRPr lang="en-US" sz="1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1828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NF-</a:t>
                      </a:r>
                      <a:r>
                        <a:rPr lang="el-GR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</a:t>
                      </a:r>
                      <a:endParaRPr lang="en-US" sz="1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endParaRPr lang="en-US" sz="1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REM-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1828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REM-1</a:t>
                      </a:r>
                    </a:p>
                    <a:p>
                      <a:endParaRPr lang="en-US" sz="1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1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1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1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1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1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1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g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g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04565033"/>
                  </a:ext>
                </a:extLst>
              </a:tr>
            </a:tbl>
          </a:graphicData>
        </a:graphic>
      </p:graphicFrame>
      <p:sp>
        <p:nvSpPr>
          <p:cNvPr id="37" name="Rectangle 36">
            <a:extLst>
              <a:ext uri="{FF2B5EF4-FFF2-40B4-BE49-F238E27FC236}">
                <a16:creationId xmlns:a16="http://schemas.microsoft.com/office/drawing/2014/main" id="{D8767F4B-209B-A028-3DB3-929F40E776B7}"/>
              </a:ext>
            </a:extLst>
          </p:cNvPr>
          <p:cNvSpPr/>
          <p:nvPr/>
        </p:nvSpPr>
        <p:spPr>
          <a:xfrm>
            <a:off x="13538640" y="10293840"/>
            <a:ext cx="534119" cy="329639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8F96C1F7-B031-06BE-346F-70C51891AD83}"/>
              </a:ext>
            </a:extLst>
          </p:cNvPr>
          <p:cNvSpPr/>
          <p:nvPr/>
        </p:nvSpPr>
        <p:spPr>
          <a:xfrm>
            <a:off x="15187744" y="10180362"/>
            <a:ext cx="534119" cy="329639"/>
          </a:xfrm>
          <a:prstGeom prst="rect">
            <a:avLst/>
          </a:prstGeom>
          <a:noFill/>
          <a:ln w="25400">
            <a:solidFill>
              <a:schemeClr val="accent1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71A87C68-76B6-A41E-EC15-B1527594B04D}"/>
              </a:ext>
            </a:extLst>
          </p:cNvPr>
          <p:cNvSpPr/>
          <p:nvPr/>
        </p:nvSpPr>
        <p:spPr>
          <a:xfrm>
            <a:off x="11877985" y="10714953"/>
            <a:ext cx="534119" cy="329639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544E9F28-4B21-4E11-4832-966E0AA14D69}"/>
              </a:ext>
            </a:extLst>
          </p:cNvPr>
          <p:cNvSpPr/>
          <p:nvPr/>
        </p:nvSpPr>
        <p:spPr>
          <a:xfrm>
            <a:off x="12444281" y="10711816"/>
            <a:ext cx="534119" cy="329639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C63AD719-4C9A-4EE4-9362-6AB36426CE77}"/>
              </a:ext>
            </a:extLst>
          </p:cNvPr>
          <p:cNvSpPr/>
          <p:nvPr/>
        </p:nvSpPr>
        <p:spPr>
          <a:xfrm>
            <a:off x="13049254" y="10679927"/>
            <a:ext cx="534119" cy="329639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BB076DD0-E04B-3451-FBFC-898496CBEA40}"/>
              </a:ext>
            </a:extLst>
          </p:cNvPr>
          <p:cNvSpPr/>
          <p:nvPr/>
        </p:nvSpPr>
        <p:spPr>
          <a:xfrm>
            <a:off x="15196442" y="10583382"/>
            <a:ext cx="534119" cy="329639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96081849-71A5-C7FC-C12A-EE61912F2897}"/>
              </a:ext>
            </a:extLst>
          </p:cNvPr>
          <p:cNvSpPr/>
          <p:nvPr/>
        </p:nvSpPr>
        <p:spPr>
          <a:xfrm>
            <a:off x="13527363" y="11133419"/>
            <a:ext cx="573588" cy="338153"/>
          </a:xfrm>
          <a:prstGeom prst="rect">
            <a:avLst/>
          </a:prstGeom>
          <a:noFill/>
          <a:ln w="25400">
            <a:solidFill>
              <a:schemeClr val="accent1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54B48AD8-1C5E-1332-F7BD-E24CB8AE5093}"/>
              </a:ext>
            </a:extLst>
          </p:cNvPr>
          <p:cNvSpPr/>
          <p:nvPr/>
        </p:nvSpPr>
        <p:spPr>
          <a:xfrm>
            <a:off x="14143431" y="11102774"/>
            <a:ext cx="573588" cy="338153"/>
          </a:xfrm>
          <a:prstGeom prst="rect">
            <a:avLst/>
          </a:prstGeom>
          <a:noFill/>
          <a:ln w="25400">
            <a:solidFill>
              <a:schemeClr val="accent1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08ED3A1F-41A4-AB98-FC88-46D599EAAA97}"/>
              </a:ext>
            </a:extLst>
          </p:cNvPr>
          <p:cNvSpPr/>
          <p:nvPr/>
        </p:nvSpPr>
        <p:spPr>
          <a:xfrm>
            <a:off x="15744498" y="10570308"/>
            <a:ext cx="534119" cy="329639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59812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9502</TotalTime>
  <Words>192</Words>
  <Application>Microsoft Office PowerPoint</Application>
  <PresentationFormat>Custom</PresentationFormat>
  <Paragraphs>8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ynak, Ahmet (kaynakat)</dc:creator>
  <cp:lastModifiedBy>Kaynak, Ahmet (kaynakat)</cp:lastModifiedBy>
  <cp:revision>76</cp:revision>
  <dcterms:created xsi:type="dcterms:W3CDTF">2021-11-16T17:09:50Z</dcterms:created>
  <dcterms:modified xsi:type="dcterms:W3CDTF">2025-01-27T17:22:59Z</dcterms:modified>
</cp:coreProperties>
</file>